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9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840" y="6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86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1490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613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819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734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3362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854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535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05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065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732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286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0EA20C4-60F1-4070-AB73-B9DC4D53D1C0}"/>
              </a:ext>
            </a:extLst>
          </p:cNvPr>
          <p:cNvSpPr txBox="1"/>
          <p:nvPr/>
        </p:nvSpPr>
        <p:spPr>
          <a:xfrm>
            <a:off x="1360051" y="3547631"/>
            <a:ext cx="7544536" cy="8210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519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S2 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hattan plot summarizing associations detected using six multi-locus approaches. Peaks in pink identify associations detected with a LOD &gt; 3.0 by at least two approaches (LOD values in pink are medians of significant approaches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415A5F9-4F3F-4AB1-8E9B-B9BBCCFE3E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7326" y="740669"/>
            <a:ext cx="7869986" cy="280696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7F4D684-5ADF-4052-B3A7-339303748817}"/>
              </a:ext>
            </a:extLst>
          </p:cNvPr>
          <p:cNvSpPr txBox="1"/>
          <p:nvPr/>
        </p:nvSpPr>
        <p:spPr>
          <a:xfrm>
            <a:off x="1360051" y="4368690"/>
            <a:ext cx="6674741" cy="845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omic prediction of zinc-biofortification potential in rice gene bank accessions</a:t>
            </a:r>
          </a:p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kotondramanan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 et al. (2022) Theoretical and Applied Genetics</a:t>
            </a:r>
          </a:p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 Matthias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ssuw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issuwa@affrc.go.jp</a:t>
            </a:r>
          </a:p>
        </p:txBody>
      </p:sp>
    </p:spTree>
    <p:extLst>
      <p:ext uri="{BB962C8B-B14F-4D97-AF65-F5344CB8AC3E}">
        <p14:creationId xmlns:p14="http://schemas.microsoft.com/office/powerpoint/2010/main" val="484471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6</TotalTime>
  <Words>75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Juan</cp:lastModifiedBy>
  <cp:revision>33</cp:revision>
  <dcterms:created xsi:type="dcterms:W3CDTF">2021-06-16T10:29:06Z</dcterms:created>
  <dcterms:modified xsi:type="dcterms:W3CDTF">2022-04-12T01:42:44Z</dcterms:modified>
</cp:coreProperties>
</file>